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2" r:id="rId2"/>
  </p:sldIdLst>
  <p:sldSz cx="7772400" cy="100584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gura, Jason (NIH/NIAID) [F]" initials="SJ([" lastIdx="1" clrIdx="0">
    <p:extLst>
      <p:ext uri="{19B8F6BF-5375-455C-9EA6-DF929625EA0E}">
        <p15:presenceInfo xmlns:p15="http://schemas.microsoft.com/office/powerpoint/2012/main" userId="S::segurajm@nih.gov::9b1b00a5-cc17-4204-89f3-061b6febed7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A01BF"/>
    <a:srgbClr val="03E2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2" autoAdjust="0"/>
    <p:restoredTop sz="96357" autoAdjust="0"/>
  </p:normalViewPr>
  <p:slideViewPr>
    <p:cSldViewPr snapToGrid="0">
      <p:cViewPr varScale="1">
        <p:scale>
          <a:sx n="78" d="100"/>
          <a:sy n="78" d="100"/>
        </p:scale>
        <p:origin x="305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475" cy="481045"/>
          </a:xfrm>
          <a:prstGeom prst="rect">
            <a:avLst/>
          </a:prstGeom>
        </p:spPr>
        <p:txBody>
          <a:bodyPr vert="horz" lIns="95069" tIns="47534" rIns="95069" bIns="4753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064" y="0"/>
            <a:ext cx="3170475" cy="481045"/>
          </a:xfrm>
          <a:prstGeom prst="rect">
            <a:avLst/>
          </a:prstGeom>
        </p:spPr>
        <p:txBody>
          <a:bodyPr vert="horz" lIns="95069" tIns="47534" rIns="95069" bIns="47534" rtlCol="0"/>
          <a:lstStyle>
            <a:lvl1pPr algn="r">
              <a:defRPr sz="1200"/>
            </a:lvl1pPr>
          </a:lstStyle>
          <a:p>
            <a:fld id="{AC15AEC4-8305-46B6-B820-9070F90C275D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200150"/>
            <a:ext cx="2505075" cy="3241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69" tIns="47534" rIns="95069" bIns="4753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004"/>
            <a:ext cx="5852160" cy="3781047"/>
          </a:xfrm>
          <a:prstGeom prst="rect">
            <a:avLst/>
          </a:prstGeom>
        </p:spPr>
        <p:txBody>
          <a:bodyPr vert="horz" lIns="95069" tIns="47534" rIns="95069" bIns="4753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56"/>
            <a:ext cx="3170475" cy="481044"/>
          </a:xfrm>
          <a:prstGeom prst="rect">
            <a:avLst/>
          </a:prstGeom>
        </p:spPr>
        <p:txBody>
          <a:bodyPr vert="horz" lIns="95069" tIns="47534" rIns="95069" bIns="4753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064" y="9120156"/>
            <a:ext cx="3170475" cy="481044"/>
          </a:xfrm>
          <a:prstGeom prst="rect">
            <a:avLst/>
          </a:prstGeom>
        </p:spPr>
        <p:txBody>
          <a:bodyPr vert="horz" lIns="95069" tIns="47534" rIns="95069" bIns="47534" rtlCol="0" anchor="b"/>
          <a:lstStyle>
            <a:lvl1pPr algn="r">
              <a:defRPr sz="1200"/>
            </a:lvl1pPr>
          </a:lstStyle>
          <a:p>
            <a:fld id="{06BD53CA-9DAD-47B5-89E1-B7E105B0A6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62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42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186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973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20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507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7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867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57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685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60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249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Rectangle 88">
            <a:extLst>
              <a:ext uri="{FF2B5EF4-FFF2-40B4-BE49-F238E27FC236}">
                <a16:creationId xmlns:a16="http://schemas.microsoft.com/office/drawing/2014/main" id="{B3029188-E13A-4794-AC8E-A8846ABDE963}"/>
              </a:ext>
            </a:extLst>
          </p:cNvPr>
          <p:cNvSpPr/>
          <p:nvPr/>
        </p:nvSpPr>
        <p:spPr>
          <a:xfrm>
            <a:off x="0" y="0"/>
            <a:ext cx="2668231" cy="5604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.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94C9CF3-A649-404B-BA84-F75AF84E89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5596385"/>
              </p:ext>
            </p:extLst>
          </p:nvPr>
        </p:nvGraphicFramePr>
        <p:xfrm>
          <a:off x="527125" y="656216"/>
          <a:ext cx="6519136" cy="28575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93448">
                  <a:extLst>
                    <a:ext uri="{9D8B030D-6E8A-4147-A177-3AD203B41FA5}">
                      <a16:colId xmlns:a16="http://schemas.microsoft.com/office/drawing/2014/main" val="395873644"/>
                    </a:ext>
                  </a:extLst>
                </a:gridCol>
                <a:gridCol w="939045">
                  <a:extLst>
                    <a:ext uri="{9D8B030D-6E8A-4147-A177-3AD203B41FA5}">
                      <a16:colId xmlns:a16="http://schemas.microsoft.com/office/drawing/2014/main" val="862695795"/>
                    </a:ext>
                  </a:extLst>
                </a:gridCol>
                <a:gridCol w="693448">
                  <a:extLst>
                    <a:ext uri="{9D8B030D-6E8A-4147-A177-3AD203B41FA5}">
                      <a16:colId xmlns:a16="http://schemas.microsoft.com/office/drawing/2014/main" val="2082055383"/>
                    </a:ext>
                  </a:extLst>
                </a:gridCol>
                <a:gridCol w="809023">
                  <a:extLst>
                    <a:ext uri="{9D8B030D-6E8A-4147-A177-3AD203B41FA5}">
                      <a16:colId xmlns:a16="http://schemas.microsoft.com/office/drawing/2014/main" val="1091700933"/>
                    </a:ext>
                  </a:extLst>
                </a:gridCol>
                <a:gridCol w="1029337">
                  <a:extLst>
                    <a:ext uri="{9D8B030D-6E8A-4147-A177-3AD203B41FA5}">
                      <a16:colId xmlns:a16="http://schemas.microsoft.com/office/drawing/2014/main" val="2416374873"/>
                    </a:ext>
                  </a:extLst>
                </a:gridCol>
                <a:gridCol w="693448">
                  <a:extLst>
                    <a:ext uri="{9D8B030D-6E8A-4147-A177-3AD203B41FA5}">
                      <a16:colId xmlns:a16="http://schemas.microsoft.com/office/drawing/2014/main" val="2994729590"/>
                    </a:ext>
                  </a:extLst>
                </a:gridCol>
                <a:gridCol w="693448">
                  <a:extLst>
                    <a:ext uri="{9D8B030D-6E8A-4147-A177-3AD203B41FA5}">
                      <a16:colId xmlns:a16="http://schemas.microsoft.com/office/drawing/2014/main" val="3878146310"/>
                    </a:ext>
                  </a:extLst>
                </a:gridCol>
                <a:gridCol w="967939">
                  <a:extLst>
                    <a:ext uri="{9D8B030D-6E8A-4147-A177-3AD203B41FA5}">
                      <a16:colId xmlns:a16="http://schemas.microsoft.com/office/drawing/2014/main" val="1958832229"/>
                    </a:ext>
                  </a:extLst>
                </a:gridCol>
              </a:tblGrid>
              <a:tr h="6572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Sample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Sample type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Total reads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# of total sequences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# of seqs with reads &gt;19</a:t>
                      </a:r>
                      <a:endParaRPr lang="en-US" sz="1200" b="1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Highest read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Average read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rotein coding sequences</a:t>
                      </a:r>
                      <a:endParaRPr lang="en-US" sz="12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724653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HIV 1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BaL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705404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895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3604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297798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354.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5314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00519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HIV 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 err="1">
                          <a:solidFill>
                            <a:sysClr val="windowText" lastClr="000000"/>
                          </a:solidFill>
                          <a:effectLst/>
                        </a:rPr>
                        <a:t>BaL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24214837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660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705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44470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50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5290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52187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HIV 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BaL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6760043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277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3809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74368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348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5039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588562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UI 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Uninfected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8636489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23142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367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344986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387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5905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6804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UI 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Uninfected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9986304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459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4184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319908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415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426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367253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UI 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Uninfected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4709910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169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579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463068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51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976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40781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+ 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+NL4-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131065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23215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947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382247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44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531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159461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+ 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+NL4-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3473640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148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4127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50908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487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91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49268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- 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-NL4-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9433787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525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4558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31127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40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4426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751511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- 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Nef-NL4-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3795137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312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4575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426127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494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5088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06204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QVD 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BaL+QVD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6262691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22626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3536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solidFill>
                            <a:sysClr val="windowText" lastClr="000000"/>
                          </a:solidFill>
                          <a:effectLst/>
                        </a:rPr>
                        <a:t>153463</a:t>
                      </a:r>
                      <a:endParaRPr lang="en-US" sz="1200" b="0" i="0" u="none" strike="noStrike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338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11606</a:t>
                      </a:r>
                      <a:endParaRPr lang="en-US" sz="1200" b="0" i="0" u="none" strike="noStrike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10828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75620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09</TotalTime>
  <Words>134</Words>
  <Application>Microsoft Office PowerPoint</Application>
  <PresentationFormat>Custom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gura, Jason (NIH/NIAID) [F]</dc:creator>
  <cp:lastModifiedBy>Sun, Peter (NIH/NIAID) [E]</cp:lastModifiedBy>
  <cp:revision>1889</cp:revision>
  <cp:lastPrinted>2022-11-29T16:07:58Z</cp:lastPrinted>
  <dcterms:created xsi:type="dcterms:W3CDTF">2018-11-20T18:59:25Z</dcterms:created>
  <dcterms:modified xsi:type="dcterms:W3CDTF">2023-01-20T15:58:37Z</dcterms:modified>
</cp:coreProperties>
</file>